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8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040FE"/>
    <a:srgbClr val="6A74D4"/>
    <a:srgbClr val="D07006"/>
    <a:srgbClr val="FFAE1D"/>
    <a:srgbClr val="285E00"/>
    <a:srgbClr val="46A400"/>
    <a:srgbClr val="C64BD3"/>
    <a:srgbClr val="DD93E5"/>
    <a:srgbClr val="92D050"/>
    <a:srgbClr val="61B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218" autoAdjust="0"/>
    <p:restoredTop sz="85427" autoAdjust="0"/>
  </p:normalViewPr>
  <p:slideViewPr>
    <p:cSldViewPr snapToGrid="0">
      <p:cViewPr varScale="1">
        <p:scale>
          <a:sx n="64" d="100"/>
          <a:sy n="64" d="100"/>
        </p:scale>
        <p:origin x="177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591C257-5060-4CB8-A54D-4F09711A5A71}" type="datetimeFigureOut">
              <a:rPr lang="en-GB" smtClean="0"/>
              <a:t>31/05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C9CE0AF-982E-4DBD-909C-CBB547C7C6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32621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31D2DA5-2C7A-426C-9893-181D72DE36DA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76818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38FA3-F05D-4D58-B051-18B4558835C6}" type="datetimeFigureOut">
              <a:rPr lang="en-GB" smtClean="0"/>
              <a:t>31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17602-519B-444F-89DD-BF3A8E523C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08309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38FA3-F05D-4D58-B051-18B4558835C6}" type="datetimeFigureOut">
              <a:rPr lang="en-GB" smtClean="0"/>
              <a:t>31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17602-519B-444F-89DD-BF3A8E523C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24247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38FA3-F05D-4D58-B051-18B4558835C6}" type="datetimeFigureOut">
              <a:rPr lang="en-GB" smtClean="0"/>
              <a:t>31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17602-519B-444F-89DD-BF3A8E523C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89845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38FA3-F05D-4D58-B051-18B4558835C6}" type="datetimeFigureOut">
              <a:rPr lang="en-GB" smtClean="0"/>
              <a:t>31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17602-519B-444F-89DD-BF3A8E523C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23589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38FA3-F05D-4D58-B051-18B4558835C6}" type="datetimeFigureOut">
              <a:rPr lang="en-GB" smtClean="0"/>
              <a:t>31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17602-519B-444F-89DD-BF3A8E523C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19070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38FA3-F05D-4D58-B051-18B4558835C6}" type="datetimeFigureOut">
              <a:rPr lang="en-GB" smtClean="0"/>
              <a:t>31/05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17602-519B-444F-89DD-BF3A8E523C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99147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38FA3-F05D-4D58-B051-18B4558835C6}" type="datetimeFigureOut">
              <a:rPr lang="en-GB" smtClean="0"/>
              <a:t>31/05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17602-519B-444F-89DD-BF3A8E523C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47692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38FA3-F05D-4D58-B051-18B4558835C6}" type="datetimeFigureOut">
              <a:rPr lang="en-GB" smtClean="0"/>
              <a:t>31/05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17602-519B-444F-89DD-BF3A8E523C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92141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38FA3-F05D-4D58-B051-18B4558835C6}" type="datetimeFigureOut">
              <a:rPr lang="en-GB" smtClean="0"/>
              <a:t>31/05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17602-519B-444F-89DD-BF3A8E523C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9987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38FA3-F05D-4D58-B051-18B4558835C6}" type="datetimeFigureOut">
              <a:rPr lang="en-GB" smtClean="0"/>
              <a:t>31/05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17602-519B-444F-89DD-BF3A8E523C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52046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38FA3-F05D-4D58-B051-18B4558835C6}" type="datetimeFigureOut">
              <a:rPr lang="en-GB" smtClean="0"/>
              <a:t>31/05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317602-519B-444F-89DD-BF3A8E523C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80274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A38FA3-F05D-4D58-B051-18B4558835C6}" type="datetimeFigureOut">
              <a:rPr lang="en-GB" smtClean="0"/>
              <a:t>31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317602-519B-444F-89DD-BF3A8E523C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66416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4DF5263F-57CB-4F0B-9D37-E2ED2049A46F}"/>
              </a:ext>
            </a:extLst>
          </p:cNvPr>
          <p:cNvSpPr txBox="1"/>
          <p:nvPr/>
        </p:nvSpPr>
        <p:spPr>
          <a:xfrm>
            <a:off x="4761220" y="192680"/>
            <a:ext cx="185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S1</a:t>
            </a: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6CC5951E-BABE-4BE2-BB8C-FB037615789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93208186"/>
              </p:ext>
            </p:extLst>
          </p:nvPr>
        </p:nvGraphicFramePr>
        <p:xfrm>
          <a:off x="1270000" y="2682225"/>
          <a:ext cx="4416698" cy="1979613"/>
        </p:xfrm>
        <a:graphic>
          <a:graphicData uri="http://schemas.openxmlformats.org/drawingml/2006/table">
            <a:tbl>
              <a:tblPr firstRow="1" firstCol="1" bandRow="1"/>
              <a:tblGrid>
                <a:gridCol w="889726">
                  <a:extLst>
                    <a:ext uri="{9D8B030D-6E8A-4147-A177-3AD203B41FA5}">
                      <a16:colId xmlns:a16="http://schemas.microsoft.com/office/drawing/2014/main" val="2859717328"/>
                    </a:ext>
                  </a:extLst>
                </a:gridCol>
                <a:gridCol w="1872343">
                  <a:extLst>
                    <a:ext uri="{9D8B030D-6E8A-4147-A177-3AD203B41FA5}">
                      <a16:colId xmlns:a16="http://schemas.microsoft.com/office/drawing/2014/main" val="3308041691"/>
                    </a:ext>
                  </a:extLst>
                </a:gridCol>
                <a:gridCol w="1654629">
                  <a:extLst>
                    <a:ext uri="{9D8B030D-6E8A-4147-A177-3AD203B41FA5}">
                      <a16:colId xmlns:a16="http://schemas.microsoft.com/office/drawing/2014/main" val="94213594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Gene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Forward (5’-3’)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Reverse (5’-3’)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5339347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CYP1B1</a:t>
                      </a:r>
                      <a:endParaRPr lang="en-GB" sz="800" dirty="0">
                        <a:effectLst/>
                        <a:latin typeface="Tahoma" panose="020B0604030504040204" pitchFamily="34" charset="0"/>
                        <a:ea typeface="Tahoma" panose="020B0604030504040204" pitchFamily="34" charset="0"/>
                        <a:cs typeface="Tahoma" panose="020B060403050404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GCTGCAGTGGCTGCTCC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CCCACGACCTGATCCAATTC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596865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SLC7A11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TCTCCAAAGGAGGTTACCTG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AGACTCCCCTCAGTAAAGTGA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543593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NQO1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ACTATGCCATGAAGGAGGCT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CCTTCAGTTTACCTGTGATGTC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099239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CXCL5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TGTTTACAGACCACGCAAG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TTGTTTCCACCGTCCAAAA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34365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CXCL8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TTGGCAGCCTTCCTGATTT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AACTTCTCCACAACCCTCT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783605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CCL5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CCAGCAGTCGTCTTTGTCA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CTCTGGGTTGGCACACACT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2541819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CCL15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TCCCAGGCCCAGTTCATAAA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TGCTTTGTGAGATGTAGGAGG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4910179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MT1G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CCTTCTCGCTTGGGAACTC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CAGCTGCACTTCTCCGAT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0353375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CD40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ACTGAAACGGAATGCCTTCC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CCTCACTCGTACAGTGCC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2909243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HLA-DRA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GTCTGGCGGCTTGAAGAAT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ACCTTGAGCCTCAAAGCTG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6135017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HPRT1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CCTGGCGTCGTGATTAGTGA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AGACGTTCAGTCCTGTCCATAA	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4450639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endParaRPr lang="en-GB" sz="400" dirty="0">
                        <a:effectLst/>
                        <a:latin typeface="Tahoma" panose="020B0604030504040204" pitchFamily="34" charset="0"/>
                        <a:ea typeface="Tahoma" panose="020B0604030504040204" pitchFamily="34" charset="0"/>
                        <a:cs typeface="Tahoma" panose="020B060403050404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endParaRPr lang="en-GB" sz="400" dirty="0">
                        <a:effectLst/>
                        <a:latin typeface="Tahoma" panose="020B0604030504040204" pitchFamily="34" charset="0"/>
                        <a:ea typeface="Tahoma" panose="020B0604030504040204" pitchFamily="34" charset="0"/>
                        <a:cs typeface="Tahoma" panose="020B060403050404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endParaRPr lang="en-GB" sz="400" dirty="0">
                        <a:effectLst/>
                        <a:latin typeface="Tahoma" panose="020B0604030504040204" pitchFamily="34" charset="0"/>
                        <a:ea typeface="Tahoma" panose="020B0604030504040204" pitchFamily="34" charset="0"/>
                        <a:cs typeface="Tahoma" panose="020B060403050404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0920836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942AA681-4D52-00AD-71DE-2AE245BECA17}"/>
              </a:ext>
            </a:extLst>
          </p:cNvPr>
          <p:cNvSpPr txBox="1"/>
          <p:nvPr/>
        </p:nvSpPr>
        <p:spPr>
          <a:xfrm>
            <a:off x="1270000" y="4813276"/>
            <a:ext cx="4656912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100" b="1" dirty="0"/>
              <a:t>Supplementary Table S1. RT-PCR primer sequences</a:t>
            </a:r>
            <a:r>
              <a:rPr lang="en-GB" sz="1100" dirty="0"/>
              <a:t>. Paired primers used for real time PCR analysis to quantify gene expression changes</a:t>
            </a:r>
          </a:p>
        </p:txBody>
      </p:sp>
    </p:spTree>
    <p:extLst>
      <p:ext uri="{BB962C8B-B14F-4D97-AF65-F5344CB8AC3E}">
        <p14:creationId xmlns:p14="http://schemas.microsoft.com/office/powerpoint/2010/main" val="35442553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500</TotalTime>
  <Words>72</Words>
  <Application>Microsoft Office PowerPoint</Application>
  <PresentationFormat>A4 Paper (210x297 mm)</PresentationFormat>
  <Paragraphs>3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ahom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tin Leonard</dc:creator>
  <cp:lastModifiedBy>Martin Leonard</cp:lastModifiedBy>
  <cp:revision>212</cp:revision>
  <dcterms:created xsi:type="dcterms:W3CDTF">2023-03-15T19:01:47Z</dcterms:created>
  <dcterms:modified xsi:type="dcterms:W3CDTF">2024-05-31T08:20:24Z</dcterms:modified>
</cp:coreProperties>
</file>